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116" d="100"/>
          <a:sy n="116" d="100"/>
        </p:scale>
        <p:origin x="82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803F1BCB-DAB5-4E05-9B67-A940EFFFF447}"/>
              </a:ext>
            </a:extLst>
          </p:cNvPr>
          <p:cNvSpPr/>
          <p:nvPr/>
        </p:nvSpPr>
        <p:spPr>
          <a:xfrm>
            <a:off x="533400" y="5244405"/>
            <a:ext cx="8153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Additional file 7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Breeding schemes for mapping the HD trait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For all crosses, mutant A/J</a:t>
            </a:r>
            <a:r>
              <a:rPr lang="en-US" sz="14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HD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males were bred with inbred females to generate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offspring. </a:t>
            </a:r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A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For backcrosses, the same mutant males were bred to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daughters to produce hundreds of N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mice, which were monitored for HD development. </a:t>
            </a:r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B.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For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2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cohorts, male and female F</a:t>
            </a:r>
            <a:r>
              <a:rPr lang="en-US" sz="14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mice were intercrossed and their offspring monitored for HD. Affected recombinants and unaffected littermates (no evidence of HD by 20-weeks old) were used in linkage analysis. B6=C57BL/6J; D2=DBA/2J; S1=129S1/</a:t>
            </a:r>
            <a:r>
              <a:rPr lang="en-US" sz="1400" dirty="0" err="1">
                <a:latin typeface="Arial" panose="020B0604020202020204" pitchFamily="34" charset="0"/>
                <a:ea typeface="Times New Roman" panose="02020603050405020304" pitchFamily="18" charset="0"/>
              </a:rPr>
              <a:t>SvImJ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; SJ=SJL/J</a:t>
            </a:r>
            <a:endParaRPr lang="en-US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003A727-8AE1-4F98-B16E-4C18C25EB5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7797" y="152400"/>
            <a:ext cx="4468406" cy="47948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6776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62</TotalTime>
  <Words>12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4</cp:revision>
  <cp:lastPrinted>2019-04-17T14:37:59Z</cp:lastPrinted>
  <dcterms:created xsi:type="dcterms:W3CDTF">2012-04-10T18:38:20Z</dcterms:created>
  <dcterms:modified xsi:type="dcterms:W3CDTF">2019-09-10T11:07:46Z</dcterms:modified>
</cp:coreProperties>
</file>